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4"/>
  </p:notesMasterIdLst>
  <p:sldIdLst>
    <p:sldId id="257" r:id="rId2"/>
    <p:sldId id="280" r:id="rId3"/>
    <p:sldId id="259" r:id="rId4"/>
    <p:sldId id="282" r:id="rId5"/>
    <p:sldId id="261" r:id="rId6"/>
    <p:sldId id="285" r:id="rId7"/>
    <p:sldId id="286" r:id="rId8"/>
    <p:sldId id="287" r:id="rId9"/>
    <p:sldId id="288" r:id="rId10"/>
    <p:sldId id="278" r:id="rId11"/>
    <p:sldId id="258" r:id="rId12"/>
    <p:sldId id="277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4" d="100"/>
          <a:sy n="104" d="100"/>
        </p:scale>
        <p:origin x="75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26A0F80-B124-4314-A8C9-2F64121B2CDC}" type="datetimeFigureOut">
              <a:rPr lang="en-US" smtClean="0"/>
              <a:t>4/28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16AAC-0619-4A05-BB15-CA50D951E7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95013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A4698-EBE7-4B5F-9A8E-DD467FBF9E9F}" type="datetimeFigureOut">
              <a:rPr lang="en-US" smtClean="0"/>
              <a:t>4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AE0FC-2FF8-43CD-A489-521DBE3E69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44740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A4698-EBE7-4B5F-9A8E-DD467FBF9E9F}" type="datetimeFigureOut">
              <a:rPr lang="en-US" smtClean="0"/>
              <a:t>4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AE0FC-2FF8-43CD-A489-521DBE3E69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65631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A4698-EBE7-4B5F-9A8E-DD467FBF9E9F}" type="datetimeFigureOut">
              <a:rPr lang="en-US" smtClean="0"/>
              <a:t>4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AE0FC-2FF8-43CD-A489-521DBE3E69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85105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A4698-EBE7-4B5F-9A8E-DD467FBF9E9F}" type="datetimeFigureOut">
              <a:rPr lang="en-US" smtClean="0"/>
              <a:t>4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AE0FC-2FF8-43CD-A489-521DBE3E69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43895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A4698-EBE7-4B5F-9A8E-DD467FBF9E9F}" type="datetimeFigureOut">
              <a:rPr lang="en-US" smtClean="0"/>
              <a:t>4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AE0FC-2FF8-43CD-A489-521DBE3E69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9193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A4698-EBE7-4B5F-9A8E-DD467FBF9E9F}" type="datetimeFigureOut">
              <a:rPr lang="en-US" smtClean="0"/>
              <a:t>4/2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AE0FC-2FF8-43CD-A489-521DBE3E69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58408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A4698-EBE7-4B5F-9A8E-DD467FBF9E9F}" type="datetimeFigureOut">
              <a:rPr lang="en-US" smtClean="0"/>
              <a:t>4/28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AE0FC-2FF8-43CD-A489-521DBE3E69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67623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A4698-EBE7-4B5F-9A8E-DD467FBF9E9F}" type="datetimeFigureOut">
              <a:rPr lang="en-US" smtClean="0"/>
              <a:t>4/28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AE0FC-2FF8-43CD-A489-521DBE3E69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0026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A4698-EBE7-4B5F-9A8E-DD467FBF9E9F}" type="datetimeFigureOut">
              <a:rPr lang="en-US" smtClean="0"/>
              <a:t>4/28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AE0FC-2FF8-43CD-A489-521DBE3E69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44983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A4698-EBE7-4B5F-9A8E-DD467FBF9E9F}" type="datetimeFigureOut">
              <a:rPr lang="en-US" smtClean="0"/>
              <a:t>4/2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AE0FC-2FF8-43CD-A489-521DBE3E69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28979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A4698-EBE7-4B5F-9A8E-DD467FBF9E9F}" type="datetimeFigureOut">
              <a:rPr lang="en-US" smtClean="0"/>
              <a:t>4/2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AE0FC-2FF8-43CD-A489-521DBE3E69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53684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1A4698-EBE7-4B5F-9A8E-DD467FBF9E9F}" type="datetimeFigureOut">
              <a:rPr lang="en-US" smtClean="0"/>
              <a:t>4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2AE0FC-2FF8-43CD-A489-521DBE3E69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1291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" name="Straight Connector 1"/>
          <p:cNvCxnSpPr/>
          <p:nvPr/>
        </p:nvCxnSpPr>
        <p:spPr>
          <a:xfrm>
            <a:off x="263614" y="625381"/>
            <a:ext cx="5486400" cy="0"/>
          </a:xfrm>
          <a:prstGeom prst="line">
            <a:avLst/>
          </a:prstGeom>
          <a:ln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3" name="Rectangle 2"/>
          <p:cNvSpPr/>
          <p:nvPr/>
        </p:nvSpPr>
        <p:spPr>
          <a:xfrm>
            <a:off x="263614" y="45265"/>
            <a:ext cx="5309146" cy="523220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2800" dirty="0" smtClean="0"/>
              <a:t>Sanger sequenced </a:t>
            </a:r>
            <a:r>
              <a:rPr lang="en-US" sz="2800" i="1" dirty="0" smtClean="0"/>
              <a:t>de novo</a:t>
            </a:r>
            <a:r>
              <a:rPr lang="en-US" sz="2800" dirty="0" smtClean="0"/>
              <a:t> variants</a:t>
            </a:r>
            <a:endParaRPr lang="en-US" sz="2800" dirty="0"/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07432837"/>
              </p:ext>
            </p:extLst>
          </p:nvPr>
        </p:nvGraphicFramePr>
        <p:xfrm>
          <a:off x="1909515" y="1297752"/>
          <a:ext cx="8167724" cy="4364460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572783">
                  <a:extLst>
                    <a:ext uri="{9D8B030D-6E8A-4147-A177-3AD203B41FA5}">
                      <a16:colId xmlns:a16="http://schemas.microsoft.com/office/drawing/2014/main" val="3022570892"/>
                    </a:ext>
                  </a:extLst>
                </a:gridCol>
                <a:gridCol w="572783">
                  <a:extLst>
                    <a:ext uri="{9D8B030D-6E8A-4147-A177-3AD203B41FA5}">
                      <a16:colId xmlns:a16="http://schemas.microsoft.com/office/drawing/2014/main" val="1342519299"/>
                    </a:ext>
                  </a:extLst>
                </a:gridCol>
                <a:gridCol w="798684">
                  <a:extLst>
                    <a:ext uri="{9D8B030D-6E8A-4147-A177-3AD203B41FA5}">
                      <a16:colId xmlns:a16="http://schemas.microsoft.com/office/drawing/2014/main" val="2463521039"/>
                    </a:ext>
                  </a:extLst>
                </a:gridCol>
                <a:gridCol w="977678">
                  <a:extLst>
                    <a:ext uri="{9D8B030D-6E8A-4147-A177-3AD203B41FA5}">
                      <a16:colId xmlns:a16="http://schemas.microsoft.com/office/drawing/2014/main" val="3756384841"/>
                    </a:ext>
                  </a:extLst>
                </a:gridCol>
                <a:gridCol w="599432">
                  <a:extLst>
                    <a:ext uri="{9D8B030D-6E8A-4147-A177-3AD203B41FA5}">
                      <a16:colId xmlns:a16="http://schemas.microsoft.com/office/drawing/2014/main" val="3753621433"/>
                    </a:ext>
                  </a:extLst>
                </a:gridCol>
                <a:gridCol w="973736">
                  <a:extLst>
                    <a:ext uri="{9D8B030D-6E8A-4147-A177-3AD203B41FA5}">
                      <a16:colId xmlns:a16="http://schemas.microsoft.com/office/drawing/2014/main" val="645078312"/>
                    </a:ext>
                  </a:extLst>
                </a:gridCol>
                <a:gridCol w="831655">
                  <a:extLst>
                    <a:ext uri="{9D8B030D-6E8A-4147-A177-3AD203B41FA5}">
                      <a16:colId xmlns:a16="http://schemas.microsoft.com/office/drawing/2014/main" val="3788163376"/>
                    </a:ext>
                  </a:extLst>
                </a:gridCol>
                <a:gridCol w="1764152">
                  <a:extLst>
                    <a:ext uri="{9D8B030D-6E8A-4147-A177-3AD203B41FA5}">
                      <a16:colId xmlns:a16="http://schemas.microsoft.com/office/drawing/2014/main" val="2521536685"/>
                    </a:ext>
                  </a:extLst>
                </a:gridCol>
                <a:gridCol w="1076821">
                  <a:extLst>
                    <a:ext uri="{9D8B030D-6E8A-4147-A177-3AD203B41FA5}">
                      <a16:colId xmlns:a16="http://schemas.microsoft.com/office/drawing/2014/main" val="2664100128"/>
                    </a:ext>
                  </a:extLst>
                </a:gridCol>
              </a:tblGrid>
              <a:tr h="640311">
                <a:tc>
                  <a:txBody>
                    <a:bodyPr/>
                    <a:lstStyle/>
                    <a:p>
                      <a:pPr algn="ctr" fontAlgn="b"/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CHROM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POS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solidFill>
                            <a:schemeClr val="tx1"/>
                          </a:solidFill>
                          <a:effectLst/>
                        </a:rPr>
                        <a:t>REF</a:t>
                      </a:r>
                      <a:endParaRPr lang="en-US" sz="12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ALT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Sample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VariantType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solidFill>
                            <a:schemeClr val="tx1"/>
                          </a:solidFill>
                          <a:effectLst/>
                        </a:rPr>
                        <a:t>Tool</a:t>
                      </a:r>
                      <a:endParaRPr lang="en-US" sz="1200" b="1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Phenotype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39401447"/>
                  </a:ext>
                </a:extLst>
              </a:tr>
              <a:tr h="33855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113236668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C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</a:rPr>
                        <a:t>G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B22_01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snp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FreeBayes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Neurogenetic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extLst>
                  <a:ext uri="{0D108BD9-81ED-4DB2-BD59-A6C34878D82A}">
                    <a16:rowId xmlns:a16="http://schemas.microsoft.com/office/drawing/2014/main" val="3267447054"/>
                  </a:ext>
                </a:extLst>
              </a:tr>
              <a:tr h="33855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166245634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C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T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M24_01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snp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FreeBayes,RUFUS,VarScan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Neurogenetic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extLst>
                  <a:ext uri="{0D108BD9-81ED-4DB2-BD59-A6C34878D82A}">
                    <a16:rowId xmlns:a16="http://schemas.microsoft.com/office/drawing/2014/main" val="100386560"/>
                  </a:ext>
                </a:extLst>
              </a:tr>
              <a:tr h="33855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3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136192388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C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T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B59_01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snp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FreeBayes,RUFUS,VarScan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Neurogenetic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extLst>
                  <a:ext uri="{0D108BD9-81ED-4DB2-BD59-A6C34878D82A}">
                    <a16:rowId xmlns:a16="http://schemas.microsoft.com/office/drawing/2014/main" val="4267322953"/>
                  </a:ext>
                </a:extLst>
              </a:tr>
              <a:tr h="33855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8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61757434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GGACAGACAT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GGACAT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M118_01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indel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FreeBayes,RUFUS,VarScan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</a:rPr>
                        <a:t>Multi-system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extLst>
                  <a:ext uri="{0D108BD9-81ED-4DB2-BD59-A6C34878D82A}">
                    <a16:rowId xmlns:a16="http://schemas.microsoft.com/office/drawing/2014/main" val="391463744"/>
                  </a:ext>
                </a:extLst>
              </a:tr>
              <a:tr h="33855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10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78647208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A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AT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B11_01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indel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RUFUS,VarScan,FreeBayes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Neurogenetic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extLst>
                  <a:ext uri="{0D108BD9-81ED-4DB2-BD59-A6C34878D82A}">
                    <a16:rowId xmlns:a16="http://schemas.microsoft.com/office/drawing/2014/main" val="2009812768"/>
                  </a:ext>
                </a:extLst>
              </a:tr>
              <a:tr h="33855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12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48183315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G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C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B35_01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snp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FreeBayes,RUFUS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Neurogenetic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extLst>
                  <a:ext uri="{0D108BD9-81ED-4DB2-BD59-A6C34878D82A}">
                    <a16:rowId xmlns:a16="http://schemas.microsoft.com/office/drawing/2014/main" val="4177914129"/>
                  </a:ext>
                </a:extLst>
              </a:tr>
              <a:tr h="33855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14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34269009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A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G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B22_01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snp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RUFUS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Neurogenetic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extLst>
                  <a:ext uri="{0D108BD9-81ED-4DB2-BD59-A6C34878D82A}">
                    <a16:rowId xmlns:a16="http://schemas.microsoft.com/office/drawing/2014/main" val="702338026"/>
                  </a:ext>
                </a:extLst>
              </a:tr>
              <a:tr h="33855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15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52676446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C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T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B05_01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snp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FreeBayes,RUFUS,VarScan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Neurogenetic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extLst>
                  <a:ext uri="{0D108BD9-81ED-4DB2-BD59-A6C34878D82A}">
                    <a16:rowId xmlns:a16="http://schemas.microsoft.com/office/drawing/2014/main" val="797677286"/>
                  </a:ext>
                </a:extLst>
              </a:tr>
              <a:tr h="33855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16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3077031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A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G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M52_01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snp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RUFUS,VarScan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</a:rPr>
                        <a:t>Craniofacial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extLst>
                  <a:ext uri="{0D108BD9-81ED-4DB2-BD59-A6C34878D82A}">
                    <a16:rowId xmlns:a16="http://schemas.microsoft.com/office/drawing/2014/main" val="3503072507"/>
                  </a:ext>
                </a:extLst>
              </a:tr>
              <a:tr h="33855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17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42971887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C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A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M85_01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snp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FreeBayes,RUFUS,VarScan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</a:rPr>
                        <a:t>Other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extLst>
                  <a:ext uri="{0D108BD9-81ED-4DB2-BD59-A6C34878D82A}">
                    <a16:rowId xmlns:a16="http://schemas.microsoft.com/office/drawing/2014/main" val="2162789948"/>
                  </a:ext>
                </a:extLst>
              </a:tr>
              <a:tr h="33855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1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22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19208943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CAG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C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M15_01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indel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</a:rPr>
                        <a:t>RUFUS,VarScan,FreeBayes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Neurogenetic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12" marR="5512" marT="5512" marB="0" anchor="ctr"/>
                </a:tc>
                <a:extLst>
                  <a:ext uri="{0D108BD9-81ED-4DB2-BD59-A6C34878D82A}">
                    <a16:rowId xmlns:a16="http://schemas.microsoft.com/office/drawing/2014/main" val="157513358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734077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Oval 23"/>
          <p:cNvSpPr/>
          <p:nvPr/>
        </p:nvSpPr>
        <p:spPr>
          <a:xfrm>
            <a:off x="0" y="0"/>
            <a:ext cx="640080" cy="640080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dirty="0"/>
              <a:t>9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14509" y="1451456"/>
            <a:ext cx="6797629" cy="4340728"/>
          </a:xfrm>
          <a:prstGeom prst="rect">
            <a:avLst/>
          </a:prstGeom>
          <a:ln w="38100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8829449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Picture 2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19527" y="1104669"/>
            <a:ext cx="4593515" cy="5577840"/>
          </a:xfrm>
          <a:prstGeom prst="rect">
            <a:avLst/>
          </a:prstGeom>
          <a:ln w="38100">
            <a:solidFill>
              <a:schemeClr val="tx1"/>
            </a:solidFill>
          </a:ln>
        </p:spPr>
      </p:pic>
      <p:sp>
        <p:nvSpPr>
          <p:cNvPr id="2" name="Oval 1"/>
          <p:cNvSpPr/>
          <p:nvPr/>
        </p:nvSpPr>
        <p:spPr>
          <a:xfrm>
            <a:off x="0" y="0"/>
            <a:ext cx="640080" cy="640080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dirty="0" smtClean="0"/>
              <a:t>10</a:t>
            </a:r>
            <a:endParaRPr lang="en-US" sz="2000" dirty="0"/>
          </a:p>
        </p:txBody>
      </p:sp>
    </p:spTree>
    <p:extLst>
      <p:ext uri="{BB962C8B-B14F-4D97-AF65-F5344CB8AC3E}">
        <p14:creationId xmlns:p14="http://schemas.microsoft.com/office/powerpoint/2010/main" val="36065985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Oval 16"/>
          <p:cNvSpPr/>
          <p:nvPr/>
        </p:nvSpPr>
        <p:spPr>
          <a:xfrm>
            <a:off x="0" y="0"/>
            <a:ext cx="640080" cy="640080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dirty="0" smtClean="0"/>
              <a:t>11</a:t>
            </a:r>
            <a:endParaRPr lang="en-US" sz="2000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56983" y="1216696"/>
            <a:ext cx="8218120" cy="48162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212666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val 1">
            <a:extLst>
              <a:ext uri="{FF2B5EF4-FFF2-40B4-BE49-F238E27FC236}">
                <a16:creationId xmlns:a16="http://schemas.microsoft.com/office/drawing/2014/main" id="{05365EA3-C90C-0444-960C-C7A3D392AFA2}"/>
              </a:ext>
            </a:extLst>
          </p:cNvPr>
          <p:cNvSpPr/>
          <p:nvPr/>
        </p:nvSpPr>
        <p:spPr>
          <a:xfrm>
            <a:off x="0" y="0"/>
            <a:ext cx="640080" cy="640080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dirty="0"/>
              <a:t>1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67211" y="898940"/>
            <a:ext cx="5657578" cy="5060119"/>
          </a:xfrm>
          <a:prstGeom prst="rect">
            <a:avLst/>
          </a:prstGeom>
          <a:ln w="38100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2999977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Oval 26"/>
          <p:cNvSpPr/>
          <p:nvPr/>
        </p:nvSpPr>
        <p:spPr>
          <a:xfrm>
            <a:off x="0" y="0"/>
            <a:ext cx="640080" cy="640080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dirty="0" smtClean="0"/>
              <a:t>2</a:t>
            </a:r>
            <a:endParaRPr lang="en-US" sz="2000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43167" y="1153685"/>
            <a:ext cx="6462320" cy="49016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1040787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val 1">
            <a:extLst>
              <a:ext uri="{FF2B5EF4-FFF2-40B4-BE49-F238E27FC236}">
                <a16:creationId xmlns:a16="http://schemas.microsoft.com/office/drawing/2014/main" id="{05365EA3-C90C-0444-960C-C7A3D392AFA2}"/>
              </a:ext>
            </a:extLst>
          </p:cNvPr>
          <p:cNvSpPr/>
          <p:nvPr/>
        </p:nvSpPr>
        <p:spPr>
          <a:xfrm>
            <a:off x="0" y="0"/>
            <a:ext cx="640080" cy="640080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dirty="0"/>
              <a:t>3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11749" y="990388"/>
            <a:ext cx="5968501" cy="4877223"/>
          </a:xfrm>
          <a:prstGeom prst="rect">
            <a:avLst/>
          </a:prstGeom>
          <a:ln w="38100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41203209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Oval 12"/>
          <p:cNvSpPr/>
          <p:nvPr/>
        </p:nvSpPr>
        <p:spPr>
          <a:xfrm>
            <a:off x="0" y="0"/>
            <a:ext cx="640080" cy="640080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dirty="0" smtClean="0"/>
              <a:t>4</a:t>
            </a:r>
            <a:endParaRPr lang="en-US" sz="2000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81266" y="923327"/>
            <a:ext cx="6029467" cy="50113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0383240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Oval 12"/>
          <p:cNvSpPr/>
          <p:nvPr/>
        </p:nvSpPr>
        <p:spPr>
          <a:xfrm>
            <a:off x="0" y="0"/>
            <a:ext cx="640080" cy="640080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dirty="0"/>
              <a:t>5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75847" y="1036112"/>
            <a:ext cx="6840305" cy="4785775"/>
          </a:xfrm>
          <a:prstGeom prst="rect">
            <a:avLst/>
          </a:prstGeom>
          <a:ln w="38100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52972718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val 1">
            <a:extLst>
              <a:ext uri="{FF2B5EF4-FFF2-40B4-BE49-F238E27FC236}">
                <a16:creationId xmlns:a16="http://schemas.microsoft.com/office/drawing/2014/main" id="{9DA7E488-501F-6941-BCDA-F86C7BECFF62}"/>
              </a:ext>
            </a:extLst>
          </p:cNvPr>
          <p:cNvSpPr/>
          <p:nvPr/>
        </p:nvSpPr>
        <p:spPr>
          <a:xfrm>
            <a:off x="0" y="0"/>
            <a:ext cx="640080" cy="640080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dirty="0"/>
              <a:t>6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20894" y="853217"/>
            <a:ext cx="5950212" cy="5151566"/>
          </a:xfrm>
          <a:prstGeom prst="rect">
            <a:avLst/>
          </a:prstGeom>
          <a:ln w="38100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03147094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val 1">
            <a:extLst>
              <a:ext uri="{FF2B5EF4-FFF2-40B4-BE49-F238E27FC236}">
                <a16:creationId xmlns:a16="http://schemas.microsoft.com/office/drawing/2014/main" id="{9DA7E488-501F-6941-BCDA-F86C7BECFF62}"/>
              </a:ext>
            </a:extLst>
          </p:cNvPr>
          <p:cNvSpPr/>
          <p:nvPr/>
        </p:nvSpPr>
        <p:spPr>
          <a:xfrm>
            <a:off x="0" y="0"/>
            <a:ext cx="640080" cy="640080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dirty="0"/>
              <a:t>7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53832" y="1036112"/>
            <a:ext cx="6084335" cy="4785775"/>
          </a:xfrm>
          <a:prstGeom prst="rect">
            <a:avLst/>
          </a:prstGeom>
          <a:ln w="38100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43531824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val 1">
            <a:extLst>
              <a:ext uri="{FF2B5EF4-FFF2-40B4-BE49-F238E27FC236}">
                <a16:creationId xmlns:a16="http://schemas.microsoft.com/office/drawing/2014/main" id="{9DA7E488-501F-6941-BCDA-F86C7BECFF62}"/>
              </a:ext>
            </a:extLst>
          </p:cNvPr>
          <p:cNvSpPr/>
          <p:nvPr/>
        </p:nvSpPr>
        <p:spPr>
          <a:xfrm>
            <a:off x="0" y="0"/>
            <a:ext cx="640080" cy="640080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dirty="0"/>
              <a:t>8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08616" y="1173284"/>
            <a:ext cx="4974767" cy="4511431"/>
          </a:xfrm>
          <a:prstGeom prst="rect">
            <a:avLst/>
          </a:prstGeom>
          <a:ln w="38100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4476516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072</TotalTime>
  <Words>123</Words>
  <Application>Microsoft Office PowerPoint</Application>
  <PresentationFormat>Widescreen</PresentationFormat>
  <Paragraphs>119</Paragraphs>
  <Slides>1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6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uhammad Kohailan</dc:creator>
  <cp:lastModifiedBy>Muhammad Kohailan</cp:lastModifiedBy>
  <cp:revision>31</cp:revision>
  <dcterms:created xsi:type="dcterms:W3CDTF">2022-04-05T17:08:32Z</dcterms:created>
  <dcterms:modified xsi:type="dcterms:W3CDTF">2022-04-28T14:47:25Z</dcterms:modified>
</cp:coreProperties>
</file>